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 snapToObjects="1">
      <p:cViewPr>
        <p:scale>
          <a:sx n="100" d="100"/>
          <a:sy n="100" d="100"/>
        </p:scale>
        <p:origin x="-296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7E9448-278F-A84D-A0F9-9F20C81665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553B01-0F16-0248-AB2B-300DC86E30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B6D11E-8FEE-104C-BA4B-4975A53A2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5F72F4-252E-C449-BD44-2690E622E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DA879E-8B9C-124E-ACDB-59330FFF6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801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086EF-6CEA-1946-85EC-AC0320110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FB9936-4C82-7F4C-9772-78F2FA1719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AEF8B8-57D8-D84E-97E0-764974F34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0B2293-86D6-7341-AB12-F6AE25A7C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115632-0319-7D40-B69B-6FB7A344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1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24940E-7B95-CA43-999A-3A9D9BA00A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94D1D0-A2B5-D64E-A251-F8EAEE6835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CC8397-01DB-9847-B2D5-FCE0E5DD3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5D4DF6-C053-6843-9E1C-9273E001F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204006-C868-EE4C-A059-3CBF23471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57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B65F5-1CB1-7E43-A85A-27A82BECD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2ED302-E308-9F42-8A3C-1C455809F4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868AAE-367C-3947-95A0-10A31FB06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7DC8B-E6FE-F049-B8C0-22FF61676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8E8C5-45D2-6C4C-AEBF-C65768F91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186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E8EB0-C770-3041-8D2C-A0D10FEBE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18FE28-A968-F84D-96D9-1F9A445E5F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20BC45-45F7-CC41-8B0C-72F2DE78C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B2E05F-2C5D-7342-9813-DA781992D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BBDE2C-D5B3-484F-AE7E-D11104934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241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E2A40E-F61C-E746-819C-903186E7E8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CE5440-6434-514A-B032-2C82AA0CB6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3CFD77-5BAB-044B-86BE-25746B7B00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C57BA6-3EE1-3B47-884B-83B78C335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2B2E0E-F2BF-A944-BBCC-C1464166B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C31A5F-C72C-8B46-B021-E7A69BF3E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951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718D9-E6D3-BC47-957F-198C145F7B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6B7018-74A7-EA48-957C-218A86FEC9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6F6045-5593-E94F-9D38-EEAE2C58A3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B7148D-EDA1-124E-B61C-116867FB4F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60BCCF-6648-B24C-96F5-E1E254372F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918BC0-4A42-1B48-9A51-8C6496D27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A65BE6-5A71-8E46-8561-5FD26B405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D129B7-FCB0-1B4F-B1FA-9A7B9AF49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625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1E0AA0-3B42-0D46-938E-E91700763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CFC028-179B-4A41-A308-84AC96AE7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62CDF8-3920-4743-A3ED-40F8F24F2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BBB9AC-B62C-CC48-AB4C-BEA15E2D4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148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C9E724-9C9D-5743-8ABA-8EB1AEEC9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49737E-9B14-0645-B8EE-5C76B3581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7C94C6-9BE5-0846-BA30-A7E95E8C6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088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3B1298-24C7-9345-99FC-7C62DCDECE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3C6115-001C-7643-A908-6A0B16AB68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AB6BAD-4A17-EB47-B06E-1C5CF121C9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961864-3F66-A140-AB46-9EED13C53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FB57AA-EC02-364C-A51E-AB1BD3C3D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7E5CDE-494F-264C-B1BF-2AFB979D3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011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66E88-6065-054F-8FD8-E2D53B7757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80B346-3FC1-2F47-BCBF-4210D76DFA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92703D-E3E4-BD4B-B44A-37EC89198D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35B4F-3B04-E143-BA2B-EB422765C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27D203-9C0A-634B-B759-47CD8779D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5D65F1-55DB-5146-9EDE-76A6F90CB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210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1E752B-2D22-D04F-B664-49DA86BF6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7B10D7-6582-5A43-A439-4D4652A320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25B24F-1383-294D-9D90-0DA6A3C942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720EA-D4F7-A84D-80EF-317E0AC80A21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4D478B-55C5-2F49-AEEA-10BAD6F017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28002C-6D93-6A42-BADA-A0218B0D00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613333-AB85-B840-8423-C56C7ECAC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494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F90A5020-109F-F443-82E3-E19EE458A61A}"/>
              </a:ext>
            </a:extLst>
          </p:cNvPr>
          <p:cNvGrpSpPr>
            <a:grpSpLocks noChangeAspect="1"/>
          </p:cNvGrpSpPr>
          <p:nvPr/>
        </p:nvGrpSpPr>
        <p:grpSpPr>
          <a:xfrm>
            <a:off x="4758429" y="827773"/>
            <a:ext cx="3239951" cy="2491372"/>
            <a:chOff x="3589341" y="1444162"/>
            <a:chExt cx="2605464" cy="200348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8B0CF50-02E1-794F-B02D-E07D6148555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856858" y="1517562"/>
              <a:ext cx="873105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typ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030C2F0-3AE3-894F-AAB6-3D1F91A4436B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751666" y="2655612"/>
              <a:ext cx="26224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/>
                <a:t>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E2DE7CB-5A71-044B-891B-45308E6DD43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749811" y="2990312"/>
              <a:ext cx="262240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/>
                <a:t>3</a:t>
              </a:r>
            </a:p>
          </p:txBody>
        </p:sp>
        <p:pic>
          <p:nvPicPr>
            <p:cNvPr id="20" name="Picture 19" descr="A picture containing text, monitor, indoor, electronics&#10;&#10;Description automatically generated">
              <a:extLst>
                <a:ext uri="{FF2B5EF4-FFF2-40B4-BE49-F238E27FC236}">
                  <a16:creationId xmlns:a16="http://schemas.microsoft.com/office/drawing/2014/main" id="{23B4248C-140D-AD49-A6FA-158487FE75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36000"/>
                      </a14:imgEffect>
                    </a14:imgLayer>
                  </a14:imgProps>
                </a:ext>
              </a:extLst>
            </a:blip>
            <a:srcRect l="17668" t="42742" r="70425" b="52726"/>
            <a:stretch/>
          </p:blipFill>
          <p:spPr>
            <a:xfrm>
              <a:off x="3956358" y="2254389"/>
              <a:ext cx="818687" cy="271686"/>
            </a:xfrm>
            <a:prstGeom prst="rect">
              <a:avLst/>
            </a:prstGeom>
          </p:spPr>
        </p:pic>
        <p:pic>
          <p:nvPicPr>
            <p:cNvPr id="23" name="Picture 22" descr="A picture containing text, monitor, indoor, electronics&#10;&#10;Description automatically generated">
              <a:extLst>
                <a:ext uri="{FF2B5EF4-FFF2-40B4-BE49-F238E27FC236}">
                  <a16:creationId xmlns:a16="http://schemas.microsoft.com/office/drawing/2014/main" id="{7476F211-9A7D-1945-A0A6-C141616296B0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58000" contrast="34000"/>
                      </a14:imgEffect>
                    </a14:imgLayer>
                  </a14:imgProps>
                </a:ext>
              </a:extLst>
            </a:blip>
            <a:srcRect l="19437" t="28689" r="69321" b="65482"/>
            <a:stretch/>
          </p:blipFill>
          <p:spPr>
            <a:xfrm>
              <a:off x="3956353" y="2948005"/>
              <a:ext cx="843040" cy="309760"/>
            </a:xfrm>
            <a:prstGeom prst="rect">
              <a:avLst/>
            </a:prstGeom>
          </p:spPr>
        </p:pic>
        <p:pic>
          <p:nvPicPr>
            <p:cNvPr id="22" name="Picture 21" descr="A picture containing text, monitor, indoor, electronics&#10;&#10;Description automatically generated">
              <a:extLst>
                <a:ext uri="{FF2B5EF4-FFF2-40B4-BE49-F238E27FC236}">
                  <a16:creationId xmlns:a16="http://schemas.microsoft.com/office/drawing/2014/main" id="{D865CC52-CE77-C347-86D3-0F4986785347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7000"/>
                      </a14:imgEffect>
                    </a14:imgLayer>
                  </a14:imgProps>
                </a:ext>
              </a:extLst>
            </a:blip>
            <a:srcRect l="47369" t="42426" r="40371" b="52881"/>
            <a:stretch/>
          </p:blipFill>
          <p:spPr>
            <a:xfrm>
              <a:off x="3955145" y="2603024"/>
              <a:ext cx="843040" cy="281174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BE74697-9559-164D-AA11-B530AAE80B49}"/>
                </a:ext>
              </a:extLst>
            </p:cNvPr>
            <p:cNvSpPr txBox="1"/>
            <p:nvPr/>
          </p:nvSpPr>
          <p:spPr>
            <a:xfrm rot="18900000">
              <a:off x="3955144" y="1971502"/>
              <a:ext cx="436561" cy="222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86C3972-87CD-D942-8511-C0D10C848DAD}"/>
                </a:ext>
              </a:extLst>
            </p:cNvPr>
            <p:cNvSpPr txBox="1"/>
            <p:nvPr/>
          </p:nvSpPr>
          <p:spPr>
            <a:xfrm rot="18900000">
              <a:off x="4140247" y="1809103"/>
              <a:ext cx="824009" cy="222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93-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42A4E55-9C38-EA4D-A71D-A761E4B0C6F3}"/>
                </a:ext>
              </a:extLst>
            </p:cNvPr>
            <p:cNvSpPr txBox="1"/>
            <p:nvPr/>
          </p:nvSpPr>
          <p:spPr>
            <a:xfrm rot="18900000">
              <a:off x="4278649" y="1444162"/>
              <a:ext cx="1916156" cy="222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93:CCDC93-RFP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93-1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D1662B6-5199-9F41-A694-44597BE2C53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753522" y="2259454"/>
              <a:ext cx="262240" cy="31089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dirty="0"/>
                <a:t>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D752EB2-3487-6146-8F21-3CEF64019FE9}"/>
                </a:ext>
              </a:extLst>
            </p:cNvPr>
            <p:cNvSpPr txBox="1"/>
            <p:nvPr/>
          </p:nvSpPr>
          <p:spPr>
            <a:xfrm rot="16200000">
              <a:off x="3005431" y="2586734"/>
              <a:ext cx="14448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Combination</a:t>
              </a:r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D4A4EE5D-52A4-D843-990F-907F679B528F}"/>
              </a:ext>
            </a:extLst>
          </p:cNvPr>
          <p:cNvGrpSpPr/>
          <p:nvPr/>
        </p:nvGrpSpPr>
        <p:grpSpPr>
          <a:xfrm>
            <a:off x="2539400" y="3448528"/>
            <a:ext cx="6268904" cy="1314004"/>
            <a:chOff x="2593349" y="3547446"/>
            <a:chExt cx="6268904" cy="1314004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352AFA8-22F3-2347-B710-A9A32BC90FDD}"/>
                </a:ext>
              </a:extLst>
            </p:cNvPr>
            <p:cNvSpPr txBox="1"/>
            <p:nvPr/>
          </p:nvSpPr>
          <p:spPr>
            <a:xfrm>
              <a:off x="7591138" y="4646006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50bp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93D24D33-6019-F94A-85AD-D42B5B19A054}"/>
                </a:ext>
              </a:extLst>
            </p:cNvPr>
            <p:cNvSpPr/>
            <p:nvPr/>
          </p:nvSpPr>
          <p:spPr>
            <a:xfrm>
              <a:off x="4912902" y="3962202"/>
              <a:ext cx="46335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74ACD107-C0B7-604A-8393-328420023AF3}"/>
                </a:ext>
              </a:extLst>
            </p:cNvPr>
            <p:cNvCxnSpPr/>
            <p:nvPr/>
          </p:nvCxnSpPr>
          <p:spPr>
            <a:xfrm>
              <a:off x="4959238" y="4028395"/>
              <a:ext cx="1621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28104C2-4F9C-464A-AE45-851902F34BAB}"/>
                </a:ext>
              </a:extLst>
            </p:cNvPr>
            <p:cNvSpPr/>
            <p:nvPr/>
          </p:nvSpPr>
          <p:spPr>
            <a:xfrm>
              <a:off x="5122445" y="3962202"/>
              <a:ext cx="132387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25C22B7D-B870-5640-958A-A2C897F8E5F9}"/>
                </a:ext>
              </a:extLst>
            </p:cNvPr>
            <p:cNvCxnSpPr/>
            <p:nvPr/>
          </p:nvCxnSpPr>
          <p:spPr>
            <a:xfrm>
              <a:off x="5242132" y="4028395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207704E-EB51-CA46-987A-EE3EF64E0425}"/>
                </a:ext>
              </a:extLst>
            </p:cNvPr>
            <p:cNvSpPr/>
            <p:nvPr/>
          </p:nvSpPr>
          <p:spPr>
            <a:xfrm>
              <a:off x="5400457" y="3962202"/>
              <a:ext cx="135697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A6E5B31F-85AF-AD47-AA70-1742A3980CB4}"/>
                </a:ext>
              </a:extLst>
            </p:cNvPr>
            <p:cNvCxnSpPr/>
            <p:nvPr/>
          </p:nvCxnSpPr>
          <p:spPr>
            <a:xfrm>
              <a:off x="5510754" y="4028395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39451ACB-5F0B-F346-854D-1465B2CBA167}"/>
                </a:ext>
              </a:extLst>
            </p:cNvPr>
            <p:cNvSpPr/>
            <p:nvPr/>
          </p:nvSpPr>
          <p:spPr>
            <a:xfrm>
              <a:off x="5632890" y="3962202"/>
              <a:ext cx="228367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79991F67-082B-1241-85DD-6D3DE03B2C25}"/>
                </a:ext>
              </a:extLst>
            </p:cNvPr>
            <p:cNvCxnSpPr/>
            <p:nvPr/>
          </p:nvCxnSpPr>
          <p:spPr>
            <a:xfrm>
              <a:off x="5861257" y="4028395"/>
              <a:ext cx="1555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4B15E6D7-3322-9248-BB9E-8BCEBCD4815C}"/>
                </a:ext>
              </a:extLst>
            </p:cNvPr>
            <p:cNvSpPr/>
            <p:nvPr/>
          </p:nvSpPr>
          <p:spPr>
            <a:xfrm>
              <a:off x="6014820" y="3962202"/>
              <a:ext cx="102600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8FD37F3F-206F-2D4F-A0C2-63702639E773}"/>
                </a:ext>
              </a:extLst>
            </p:cNvPr>
            <p:cNvCxnSpPr/>
            <p:nvPr/>
          </p:nvCxnSpPr>
          <p:spPr>
            <a:xfrm>
              <a:off x="6117420" y="4028395"/>
              <a:ext cx="3806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BAC6345B-4A0A-1342-9E71-413699F18585}"/>
                </a:ext>
              </a:extLst>
            </p:cNvPr>
            <p:cNvSpPr/>
            <p:nvPr/>
          </p:nvSpPr>
          <p:spPr>
            <a:xfrm>
              <a:off x="6498033" y="3962202"/>
              <a:ext cx="49645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53E62B4C-59D8-2847-8FEC-00268FBF76C4}"/>
                </a:ext>
              </a:extLst>
            </p:cNvPr>
            <p:cNvCxnSpPr/>
            <p:nvPr/>
          </p:nvCxnSpPr>
          <p:spPr>
            <a:xfrm>
              <a:off x="6547762" y="4028395"/>
              <a:ext cx="1390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794DDA74-E0C4-7848-8A07-EB98264D8AC8}"/>
                </a:ext>
              </a:extLst>
            </p:cNvPr>
            <p:cNvSpPr/>
            <p:nvPr/>
          </p:nvSpPr>
          <p:spPr>
            <a:xfrm>
              <a:off x="6690944" y="3962202"/>
              <a:ext cx="135697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DE62DBC4-7B76-8046-9927-F99818CE4927}"/>
                </a:ext>
              </a:extLst>
            </p:cNvPr>
            <p:cNvCxnSpPr/>
            <p:nvPr/>
          </p:nvCxnSpPr>
          <p:spPr>
            <a:xfrm>
              <a:off x="6826641" y="4028395"/>
              <a:ext cx="2713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5218AC47-C042-4541-B036-F1C87C7A531F}"/>
                </a:ext>
              </a:extLst>
            </p:cNvPr>
            <p:cNvSpPr/>
            <p:nvPr/>
          </p:nvSpPr>
          <p:spPr>
            <a:xfrm>
              <a:off x="7095165" y="3962202"/>
              <a:ext cx="102600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54548CB8-DC9D-4849-A5E8-396FC968E99D}"/>
                </a:ext>
              </a:extLst>
            </p:cNvPr>
            <p:cNvCxnSpPr/>
            <p:nvPr/>
          </p:nvCxnSpPr>
          <p:spPr>
            <a:xfrm>
              <a:off x="7159664" y="4028395"/>
              <a:ext cx="2743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3CE47D0D-C09E-EA43-B2F7-D19F660CCBB7}"/>
                </a:ext>
              </a:extLst>
            </p:cNvPr>
            <p:cNvSpPr/>
            <p:nvPr/>
          </p:nvSpPr>
          <p:spPr>
            <a:xfrm>
              <a:off x="7334271" y="3962202"/>
              <a:ext cx="155555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7460947C-71E2-7748-A2DC-AF0A387000C6}"/>
                </a:ext>
              </a:extLst>
            </p:cNvPr>
            <p:cNvCxnSpPr/>
            <p:nvPr/>
          </p:nvCxnSpPr>
          <p:spPr>
            <a:xfrm>
              <a:off x="7489826" y="4028395"/>
              <a:ext cx="1059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8B8EEB02-B8BE-CA48-9445-47C174F21E63}"/>
                </a:ext>
              </a:extLst>
            </p:cNvPr>
            <p:cNvSpPr/>
            <p:nvPr/>
          </p:nvSpPr>
          <p:spPr>
            <a:xfrm>
              <a:off x="7591138" y="3962202"/>
              <a:ext cx="79432" cy="131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3090FF1B-4146-6649-8BED-5B5F4C307F9C}"/>
                </a:ext>
              </a:extLst>
            </p:cNvPr>
            <p:cNvCxnSpPr/>
            <p:nvPr/>
          </p:nvCxnSpPr>
          <p:spPr>
            <a:xfrm>
              <a:off x="7327487" y="4764715"/>
              <a:ext cx="3000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riangle 47">
              <a:extLst>
                <a:ext uri="{FF2B5EF4-FFF2-40B4-BE49-F238E27FC236}">
                  <a16:creationId xmlns:a16="http://schemas.microsoft.com/office/drawing/2014/main" id="{D8D782B1-6CA0-E946-86FC-168E444A6F7A}"/>
                </a:ext>
              </a:extLst>
            </p:cNvPr>
            <p:cNvSpPr>
              <a:spLocks/>
            </p:cNvSpPr>
            <p:nvPr/>
          </p:nvSpPr>
          <p:spPr>
            <a:xfrm rot="10800000">
              <a:off x="7002779" y="3865545"/>
              <a:ext cx="217069" cy="91045"/>
            </a:xfrm>
            <a:prstGeom prst="triangle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D2A7B640-872E-1448-8825-723FD018BE26}"/>
                </a:ext>
              </a:extLst>
            </p:cNvPr>
            <p:cNvSpPr>
              <a:spLocks/>
            </p:cNvSpPr>
            <p:nvPr/>
          </p:nvSpPr>
          <p:spPr>
            <a:xfrm>
              <a:off x="7670173" y="3963210"/>
              <a:ext cx="813816" cy="12801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53A40703-EE02-B649-B733-95F5345D4274}"/>
                </a:ext>
              </a:extLst>
            </p:cNvPr>
            <p:cNvCxnSpPr/>
            <p:nvPr/>
          </p:nvCxnSpPr>
          <p:spPr>
            <a:xfrm>
              <a:off x="2716418" y="4031600"/>
              <a:ext cx="219456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Left Brace 50">
              <a:extLst>
                <a:ext uri="{FF2B5EF4-FFF2-40B4-BE49-F238E27FC236}">
                  <a16:creationId xmlns:a16="http://schemas.microsoft.com/office/drawing/2014/main" id="{86248A96-94C2-054F-99D4-F4832183176B}"/>
                </a:ext>
              </a:extLst>
            </p:cNvPr>
            <p:cNvSpPr/>
            <p:nvPr/>
          </p:nvSpPr>
          <p:spPr>
            <a:xfrm rot="16200000">
              <a:off x="3735974" y="3158783"/>
              <a:ext cx="155448" cy="2194560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Left Brace 51">
              <a:extLst>
                <a:ext uri="{FF2B5EF4-FFF2-40B4-BE49-F238E27FC236}">
                  <a16:creationId xmlns:a16="http://schemas.microsoft.com/office/drawing/2014/main" id="{54ECEE08-BC3C-5848-B47F-1F45F8BEC529}"/>
                </a:ext>
              </a:extLst>
            </p:cNvPr>
            <p:cNvSpPr/>
            <p:nvPr/>
          </p:nvSpPr>
          <p:spPr>
            <a:xfrm rot="16200000">
              <a:off x="6191575" y="2880016"/>
              <a:ext cx="198003" cy="2759196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Left Brace 52">
              <a:extLst>
                <a:ext uri="{FF2B5EF4-FFF2-40B4-BE49-F238E27FC236}">
                  <a16:creationId xmlns:a16="http://schemas.microsoft.com/office/drawing/2014/main" id="{32E2E284-D161-C243-B1B2-59ED593DFE59}"/>
                </a:ext>
              </a:extLst>
            </p:cNvPr>
            <p:cNvSpPr/>
            <p:nvPr/>
          </p:nvSpPr>
          <p:spPr>
            <a:xfrm rot="16200000">
              <a:off x="7990214" y="3854282"/>
              <a:ext cx="173736" cy="813817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5A32ADF-1BB6-4B41-8228-D9C1892BB48F}"/>
                </a:ext>
              </a:extLst>
            </p:cNvPr>
            <p:cNvSpPr txBox="1"/>
            <p:nvPr/>
          </p:nvSpPr>
          <p:spPr>
            <a:xfrm>
              <a:off x="7334271" y="4348059"/>
              <a:ext cx="1527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RFP Coding Sequence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ADE4F4A-C092-9642-AFAB-02E83CA5EBBC}"/>
                </a:ext>
              </a:extLst>
            </p:cNvPr>
            <p:cNvSpPr txBox="1"/>
            <p:nvPr/>
          </p:nvSpPr>
          <p:spPr>
            <a:xfrm>
              <a:off x="5392351" y="4349289"/>
              <a:ext cx="19159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CCDC93</a:t>
              </a:r>
              <a:r>
                <a:rPr lang="en-US" sz="1200" dirty="0"/>
                <a:t> Genomic Sequence</a:t>
              </a:r>
              <a:endParaRPr lang="en-US" sz="1200" i="1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2A0BBAA-6E7A-DF44-8E60-6DC14825B7F7}"/>
                </a:ext>
              </a:extLst>
            </p:cNvPr>
            <p:cNvSpPr txBox="1"/>
            <p:nvPr/>
          </p:nvSpPr>
          <p:spPr>
            <a:xfrm>
              <a:off x="3159192" y="4348059"/>
              <a:ext cx="13090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CCDC93</a:t>
              </a:r>
              <a:r>
                <a:rPr lang="en-US" sz="1200" dirty="0"/>
                <a:t> Promoter</a:t>
              </a:r>
              <a:endParaRPr lang="en-US" sz="1200" i="1" dirty="0"/>
            </a:p>
          </p:txBody>
        </p: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id="{9F7D41CC-1B34-A84D-9390-DCCABA9D340B}"/>
                </a:ext>
              </a:extLst>
            </p:cNvPr>
            <p:cNvCxnSpPr>
              <a:cxnSpLocks/>
            </p:cNvCxnSpPr>
            <p:nvPr/>
          </p:nvCxnSpPr>
          <p:spPr>
            <a:xfrm>
              <a:off x="2754518" y="3888077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75A503E0-DE0A-204C-BBD8-C81CC79778D0}"/>
                </a:ext>
              </a:extLst>
            </p:cNvPr>
            <p:cNvCxnSpPr>
              <a:cxnSpLocks/>
            </p:cNvCxnSpPr>
            <p:nvPr/>
          </p:nvCxnSpPr>
          <p:spPr>
            <a:xfrm>
              <a:off x="4944505" y="3875377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625B73D9-867C-7A42-8256-2FD546823DC9}"/>
                </a:ext>
              </a:extLst>
            </p:cNvPr>
            <p:cNvCxnSpPr/>
            <p:nvPr/>
          </p:nvCxnSpPr>
          <p:spPr>
            <a:xfrm flipH="1">
              <a:off x="7573882" y="3852736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7905C096-A2F4-E042-9FDF-A447860A2E18}"/>
                </a:ext>
              </a:extLst>
            </p:cNvPr>
            <p:cNvCxnSpPr/>
            <p:nvPr/>
          </p:nvCxnSpPr>
          <p:spPr>
            <a:xfrm flipH="1">
              <a:off x="8323182" y="3840036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5828EC79-61C0-4749-8BEC-EA14BD09694C}"/>
                </a:ext>
              </a:extLst>
            </p:cNvPr>
            <p:cNvCxnSpPr/>
            <p:nvPr/>
          </p:nvCxnSpPr>
          <p:spPr>
            <a:xfrm flipH="1">
              <a:off x="7002382" y="3801936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72EB263-8BFE-2D4D-B637-B16F130307B5}"/>
                </a:ext>
              </a:extLst>
            </p:cNvPr>
            <p:cNvSpPr txBox="1"/>
            <p:nvPr/>
          </p:nvSpPr>
          <p:spPr>
            <a:xfrm>
              <a:off x="4743969" y="3608078"/>
              <a:ext cx="401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/2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8BD14E42-D6D7-B74E-9C1A-A67C8332A93C}"/>
                </a:ext>
              </a:extLst>
            </p:cNvPr>
            <p:cNvSpPr txBox="1"/>
            <p:nvPr/>
          </p:nvSpPr>
          <p:spPr>
            <a:xfrm>
              <a:off x="6922209" y="354744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16D7864E-E0FF-D04F-B087-B7790663506E}"/>
                </a:ext>
              </a:extLst>
            </p:cNvPr>
            <p:cNvSpPr txBox="1"/>
            <p:nvPr/>
          </p:nvSpPr>
          <p:spPr>
            <a:xfrm>
              <a:off x="7508955" y="359396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1C5C5D1-A876-7B40-863C-06C364F4DDE5}"/>
                </a:ext>
              </a:extLst>
            </p:cNvPr>
            <p:cNvSpPr txBox="1"/>
            <p:nvPr/>
          </p:nvSpPr>
          <p:spPr>
            <a:xfrm>
              <a:off x="8246982" y="356303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48CF36E8-D98D-5D42-90AD-D260D1AA944E}"/>
                </a:ext>
              </a:extLst>
            </p:cNvPr>
            <p:cNvSpPr txBox="1"/>
            <p:nvPr/>
          </p:nvSpPr>
          <p:spPr>
            <a:xfrm>
              <a:off x="2593349" y="360815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id="{6974F934-DB66-B549-883E-D8E22AA642C0}"/>
              </a:ext>
            </a:extLst>
          </p:cNvPr>
          <p:cNvSpPr txBox="1"/>
          <p:nvPr/>
        </p:nvSpPr>
        <p:spPr>
          <a:xfrm>
            <a:off x="4414838" y="12715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3ECFD51-4994-EA46-A30F-F1C258D9E9CB}"/>
              </a:ext>
            </a:extLst>
          </p:cNvPr>
          <p:cNvSpPr txBox="1"/>
          <p:nvPr/>
        </p:nvSpPr>
        <p:spPr>
          <a:xfrm>
            <a:off x="2800350" y="310038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96388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7</TotalTime>
  <Words>30</Words>
  <Application>Microsoft Macintosh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Lewis</dc:creator>
  <cp:lastModifiedBy>Connor Lewis</cp:lastModifiedBy>
  <cp:revision>4</cp:revision>
  <dcterms:created xsi:type="dcterms:W3CDTF">2022-09-13T16:55:11Z</dcterms:created>
  <dcterms:modified xsi:type="dcterms:W3CDTF">2022-11-18T18:59:09Z</dcterms:modified>
</cp:coreProperties>
</file>